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4" r:id="rId3"/>
    <p:sldId id="277" r:id="rId4"/>
    <p:sldId id="273" r:id="rId5"/>
    <p:sldId id="278" r:id="rId6"/>
    <p:sldId id="270" r:id="rId7"/>
    <p:sldId id="280" r:id="rId8"/>
    <p:sldId id="641" r:id="rId9"/>
    <p:sldId id="642" r:id="rId10"/>
    <p:sldId id="285" r:id="rId11"/>
    <p:sldId id="286" r:id="rId12"/>
    <p:sldId id="298" r:id="rId13"/>
    <p:sldId id="640" r:id="rId14"/>
    <p:sldId id="643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nder%20Neuwelt\Documents\9.22.22\9.23.2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nder%20Neuwelt\Documents\8.23.22\phagocytosis.8.28.22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Book3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nder%20Neuwelt\Documents\9.22.22\9.23.2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nder%20Neuwelt\Documents\9.22.22\9.23.2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nder%20Neuwelt\Documents\9.22.22\9.23.2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nder%20Neuwelt\Documents\9.22.22\9.23.2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nder%20Neuwelt\Documents\6.26.22\phagocytosi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Book3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Book3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lexander%20Neuwelt\Documents\9.14.22.revisedcytek\CD206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Z$6:$Z$9</c:f>
                <c:numCache>
                  <c:formatCode>General</c:formatCode>
                  <c:ptCount val="4"/>
                  <c:pt idx="0">
                    <c:v>50.332229568471661</c:v>
                  </c:pt>
                  <c:pt idx="1">
                    <c:v>110.15141094572222</c:v>
                  </c:pt>
                  <c:pt idx="2">
                    <c:v>100.16652800877803</c:v>
                  </c:pt>
                  <c:pt idx="3">
                    <c:v>20.816659994661325</c:v>
                  </c:pt>
                </c:numCache>
              </c:numRef>
            </c:plus>
            <c:minus>
              <c:numRef>
                <c:f>Sheet1!$Z$6:$Z$9</c:f>
                <c:numCache>
                  <c:formatCode>General</c:formatCode>
                  <c:ptCount val="4"/>
                  <c:pt idx="0">
                    <c:v>50.332229568471661</c:v>
                  </c:pt>
                  <c:pt idx="1">
                    <c:v>110.15141094572222</c:v>
                  </c:pt>
                  <c:pt idx="2">
                    <c:v>100.16652800877803</c:v>
                  </c:pt>
                  <c:pt idx="3">
                    <c:v>20.8166599946613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X$6:$X$9</c:f>
              <c:strCache>
                <c:ptCount val="4"/>
                <c:pt idx="0">
                  <c:v>MO VEH</c:v>
                </c:pt>
                <c:pt idx="1">
                  <c:v>M1 VEH</c:v>
                </c:pt>
                <c:pt idx="2">
                  <c:v>M1 NAC</c:v>
                </c:pt>
                <c:pt idx="3">
                  <c:v>M1 AAP/NAC</c:v>
                </c:pt>
              </c:strCache>
            </c:strRef>
          </c:cat>
          <c:val>
            <c:numRef>
              <c:f>Sheet1!$Y$6:$Y$9</c:f>
              <c:numCache>
                <c:formatCode>General</c:formatCode>
                <c:ptCount val="4"/>
                <c:pt idx="0">
                  <c:v>853.33333333333337</c:v>
                </c:pt>
                <c:pt idx="1">
                  <c:v>593.33333333333337</c:v>
                </c:pt>
                <c:pt idx="2">
                  <c:v>476.66666666666669</c:v>
                </c:pt>
                <c:pt idx="3">
                  <c:v>823.3333333333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AB4-48AA-8011-292B618C49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9693488"/>
        <c:axId val="159697648"/>
      </c:barChart>
      <c:catAx>
        <c:axId val="1596934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697648"/>
        <c:crosses val="autoZero"/>
        <c:auto val="1"/>
        <c:lblAlgn val="ctr"/>
        <c:lblOffset val="100"/>
        <c:noMultiLvlLbl val="0"/>
      </c:catAx>
      <c:valAx>
        <c:axId val="1596976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6934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V$12:$V$13</c:f>
                <c:numCache>
                  <c:formatCode>General</c:formatCode>
                  <c:ptCount val="2"/>
                  <c:pt idx="0">
                    <c:v>6</c:v>
                  </c:pt>
                  <c:pt idx="1">
                    <c:v>4</c:v>
                  </c:pt>
                </c:numCache>
              </c:numRef>
            </c:plus>
            <c:minus>
              <c:numRef>
                <c:f>Sheet1!$V$12:$V$13</c:f>
                <c:numCache>
                  <c:formatCode>General</c:formatCode>
                  <c:ptCount val="2"/>
                  <c:pt idx="0">
                    <c:v>6</c:v>
                  </c:pt>
                  <c:pt idx="1">
                    <c:v>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T$12:$T$13</c:f>
              <c:strCache>
                <c:ptCount val="2"/>
                <c:pt idx="0">
                  <c:v>NAC</c:v>
                </c:pt>
                <c:pt idx="1">
                  <c:v>AAP/NAC</c:v>
                </c:pt>
              </c:strCache>
            </c:strRef>
          </c:cat>
          <c:val>
            <c:numRef>
              <c:f>Sheet1!$U$12:$U$13</c:f>
              <c:numCache>
                <c:formatCode>General</c:formatCode>
                <c:ptCount val="2"/>
                <c:pt idx="0">
                  <c:v>20</c:v>
                </c:pt>
                <c:pt idx="1">
                  <c:v>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E5-4EB2-BF12-5789518301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36795248"/>
        <c:axId val="1436792336"/>
      </c:barChart>
      <c:catAx>
        <c:axId val="1436795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36792336"/>
        <c:crosses val="autoZero"/>
        <c:auto val="1"/>
        <c:lblAlgn val="ctr"/>
        <c:lblOffset val="100"/>
        <c:noMultiLvlLbl val="0"/>
      </c:catAx>
      <c:valAx>
        <c:axId val="14367923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367952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8:$G$9</c:f>
                <c:numCache>
                  <c:formatCode>General</c:formatCode>
                  <c:ptCount val="2"/>
                  <c:pt idx="0">
                    <c:v>8.5049005481153639</c:v>
                  </c:pt>
                  <c:pt idx="1">
                    <c:v>2.3094010767585034</c:v>
                  </c:pt>
                </c:numCache>
              </c:numRef>
            </c:plus>
            <c:minus>
              <c:numRef>
                <c:f>Sheet1!$G$8:$G$9</c:f>
                <c:numCache>
                  <c:formatCode>General</c:formatCode>
                  <c:ptCount val="2"/>
                  <c:pt idx="0">
                    <c:v>8.5049005481153639</c:v>
                  </c:pt>
                  <c:pt idx="1">
                    <c:v>2.30940107675850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8:$E$9</c:f>
              <c:strCache>
                <c:ptCount val="2"/>
                <c:pt idx="0">
                  <c:v>NAC</c:v>
                </c:pt>
                <c:pt idx="1">
                  <c:v>AAP/NAC</c:v>
                </c:pt>
              </c:strCache>
            </c:strRef>
          </c:cat>
          <c:val>
            <c:numRef>
              <c:f>Sheet1!$F$8:$F$9</c:f>
              <c:numCache>
                <c:formatCode>General</c:formatCode>
                <c:ptCount val="2"/>
                <c:pt idx="0">
                  <c:v>60.666666666666664</c:v>
                </c:pt>
                <c:pt idx="1">
                  <c:v>76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AD-4AC8-A878-3E91B096D0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48905600"/>
        <c:axId val="1648906016"/>
      </c:barChart>
      <c:catAx>
        <c:axId val="1648905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8906016"/>
        <c:crosses val="autoZero"/>
        <c:auto val="1"/>
        <c:lblAlgn val="ctr"/>
        <c:lblOffset val="100"/>
        <c:noMultiLvlLbl val="0"/>
      </c:catAx>
      <c:valAx>
        <c:axId val="164890601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489056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Z$11:$Z$14</c:f>
                <c:numCache>
                  <c:formatCode>General</c:formatCode>
                  <c:ptCount val="4"/>
                  <c:pt idx="0">
                    <c:v>28.867513459481287</c:v>
                  </c:pt>
                  <c:pt idx="1">
                    <c:v>79.75796720913425</c:v>
                  </c:pt>
                  <c:pt idx="2">
                    <c:v>28.867513459481287</c:v>
                  </c:pt>
                  <c:pt idx="3">
                    <c:v>20.816659994661325</c:v>
                  </c:pt>
                </c:numCache>
              </c:numRef>
            </c:plus>
            <c:minus>
              <c:numRef>
                <c:f>Sheet1!$Z$11:$Z$14</c:f>
                <c:numCache>
                  <c:formatCode>General</c:formatCode>
                  <c:ptCount val="4"/>
                  <c:pt idx="0">
                    <c:v>28.867513459481287</c:v>
                  </c:pt>
                  <c:pt idx="1">
                    <c:v>79.75796720913425</c:v>
                  </c:pt>
                  <c:pt idx="2">
                    <c:v>28.867513459481287</c:v>
                  </c:pt>
                  <c:pt idx="3">
                    <c:v>20.8166599946613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X$11:$X$14</c:f>
              <c:strCache>
                <c:ptCount val="4"/>
                <c:pt idx="0">
                  <c:v>MO VEH</c:v>
                </c:pt>
                <c:pt idx="1">
                  <c:v>M1 VEH</c:v>
                </c:pt>
                <c:pt idx="2">
                  <c:v>M1 NAC</c:v>
                </c:pt>
                <c:pt idx="3">
                  <c:v>M1 AAP/NAC</c:v>
                </c:pt>
              </c:strCache>
            </c:strRef>
          </c:cat>
          <c:val>
            <c:numRef>
              <c:f>Sheet1!$Y$11:$Y$14</c:f>
              <c:numCache>
                <c:formatCode>General</c:formatCode>
                <c:ptCount val="4"/>
                <c:pt idx="0">
                  <c:v>666.66666666666663</c:v>
                </c:pt>
                <c:pt idx="1">
                  <c:v>690.66666666666663</c:v>
                </c:pt>
                <c:pt idx="2">
                  <c:v>716.66666666666663</c:v>
                </c:pt>
                <c:pt idx="3">
                  <c:v>753.3333333333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C0-4D93-B1D5-B0A7FE52A9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234640"/>
        <c:axId val="168228816"/>
      </c:barChart>
      <c:catAx>
        <c:axId val="168234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228816"/>
        <c:crosses val="autoZero"/>
        <c:auto val="1"/>
        <c:lblAlgn val="ctr"/>
        <c:lblOffset val="100"/>
        <c:noMultiLvlLbl val="0"/>
      </c:catAx>
      <c:valAx>
        <c:axId val="168228816"/>
        <c:scaling>
          <c:orientation val="minMax"/>
          <c:max val="1000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234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M$7:$M$10</c:f>
                <c:numCache>
                  <c:formatCode>General</c:formatCode>
                  <c:ptCount val="4"/>
                  <c:pt idx="0">
                    <c:v>721.11025509279784</c:v>
                  </c:pt>
                  <c:pt idx="1">
                    <c:v>1101.5141094572216</c:v>
                  </c:pt>
                  <c:pt idx="2">
                    <c:v>838.64970836060979</c:v>
                  </c:pt>
                  <c:pt idx="3">
                    <c:v>321.45502536643187</c:v>
                  </c:pt>
                </c:numCache>
              </c:numRef>
            </c:plus>
            <c:minus>
              <c:numRef>
                <c:f>Sheet1!$M$7:$M$10</c:f>
                <c:numCache>
                  <c:formatCode>General</c:formatCode>
                  <c:ptCount val="4"/>
                  <c:pt idx="0">
                    <c:v>721.11025509279784</c:v>
                  </c:pt>
                  <c:pt idx="1">
                    <c:v>1101.5141094572216</c:v>
                  </c:pt>
                  <c:pt idx="2">
                    <c:v>838.64970836060979</c:v>
                  </c:pt>
                  <c:pt idx="3">
                    <c:v>321.455025366431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K$7:$K$10</c:f>
              <c:strCache>
                <c:ptCount val="4"/>
                <c:pt idx="0">
                  <c:v>Veh</c:v>
                </c:pt>
                <c:pt idx="1">
                  <c:v>IL-4 + Veh</c:v>
                </c:pt>
                <c:pt idx="2">
                  <c:v>IL-4 + NAC</c:v>
                </c:pt>
                <c:pt idx="3">
                  <c:v>IL-4 + AAP/NAC</c:v>
                </c:pt>
              </c:strCache>
            </c:strRef>
          </c:cat>
          <c:val>
            <c:numRef>
              <c:f>Sheet1!$L$7:$L$10</c:f>
              <c:numCache>
                <c:formatCode>General</c:formatCode>
                <c:ptCount val="4"/>
                <c:pt idx="0">
                  <c:v>4700</c:v>
                </c:pt>
                <c:pt idx="1">
                  <c:v>5266.666666666667</c:v>
                </c:pt>
                <c:pt idx="2">
                  <c:v>4766.666666666667</c:v>
                </c:pt>
                <c:pt idx="3">
                  <c:v>5066.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78-47C7-9B6D-3BCBDD3080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0204704"/>
        <c:axId val="910214688"/>
      </c:barChart>
      <c:catAx>
        <c:axId val="910204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0214688"/>
        <c:crosses val="autoZero"/>
        <c:auto val="1"/>
        <c:lblAlgn val="ctr"/>
        <c:lblOffset val="100"/>
        <c:noMultiLvlLbl val="0"/>
      </c:catAx>
      <c:valAx>
        <c:axId val="910214688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0204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1:$E$24</c:f>
                <c:numCache>
                  <c:formatCode>General</c:formatCode>
                  <c:ptCount val="4"/>
                  <c:pt idx="0">
                    <c:v>953.93920141694559</c:v>
                  </c:pt>
                  <c:pt idx="1">
                    <c:v>0</c:v>
                  </c:pt>
                  <c:pt idx="2">
                    <c:v>346.41016151377545</c:v>
                  </c:pt>
                  <c:pt idx="3">
                    <c:v>577.35026918962569</c:v>
                  </c:pt>
                </c:numCache>
              </c:numRef>
            </c:plus>
            <c:minus>
              <c:numRef>
                <c:f>Sheet1!$E$21:$E$24</c:f>
                <c:numCache>
                  <c:formatCode>General</c:formatCode>
                  <c:ptCount val="4"/>
                  <c:pt idx="0">
                    <c:v>953.93920141694559</c:v>
                  </c:pt>
                  <c:pt idx="1">
                    <c:v>0</c:v>
                  </c:pt>
                  <c:pt idx="2">
                    <c:v>346.41016151377545</c:v>
                  </c:pt>
                  <c:pt idx="3">
                    <c:v>577.350269189625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21:$C$24</c:f>
              <c:strCache>
                <c:ptCount val="4"/>
                <c:pt idx="0">
                  <c:v>Veh</c:v>
                </c:pt>
                <c:pt idx="1">
                  <c:v>IL-4 + Veh</c:v>
                </c:pt>
                <c:pt idx="2">
                  <c:v>IL-4 + NAC</c:v>
                </c:pt>
                <c:pt idx="3">
                  <c:v>IL-4 + AAP/NAC</c:v>
                </c:pt>
              </c:strCache>
            </c:strRef>
          </c:cat>
          <c:val>
            <c:numRef>
              <c:f>Sheet1!$D$21:$D$24</c:f>
              <c:numCache>
                <c:formatCode>General</c:formatCode>
                <c:ptCount val="4"/>
                <c:pt idx="0">
                  <c:v>7200</c:v>
                </c:pt>
                <c:pt idx="1">
                  <c:v>11000</c:v>
                </c:pt>
                <c:pt idx="2">
                  <c:v>13200</c:v>
                </c:pt>
                <c:pt idx="3">
                  <c:v>11333.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4D-4DDD-AE5F-F14F22B1BF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9715584"/>
        <c:axId val="399712672"/>
      </c:barChart>
      <c:catAx>
        <c:axId val="399715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9712672"/>
        <c:crosses val="autoZero"/>
        <c:auto val="1"/>
        <c:lblAlgn val="ctr"/>
        <c:lblOffset val="100"/>
        <c:noMultiLvlLbl val="0"/>
      </c:catAx>
      <c:valAx>
        <c:axId val="399712672"/>
        <c:scaling>
          <c:orientation val="minMax"/>
          <c:max val="300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97155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32:$E$35</c:f>
                <c:numCache>
                  <c:formatCode>General</c:formatCode>
                  <c:ptCount val="4"/>
                  <c:pt idx="0">
                    <c:v>57.735026918962575</c:v>
                  </c:pt>
                  <c:pt idx="1">
                    <c:v>57.735026918962575</c:v>
                  </c:pt>
                  <c:pt idx="2">
                    <c:v>57.735026918962575</c:v>
                  </c:pt>
                  <c:pt idx="3">
                    <c:v>57.735026918962575</c:v>
                  </c:pt>
                </c:numCache>
              </c:numRef>
            </c:plus>
            <c:minus>
              <c:numRef>
                <c:f>Sheet1!$E$32:$E$35</c:f>
                <c:numCache>
                  <c:formatCode>General</c:formatCode>
                  <c:ptCount val="4"/>
                  <c:pt idx="0">
                    <c:v>57.735026918962575</c:v>
                  </c:pt>
                  <c:pt idx="1">
                    <c:v>57.735026918962575</c:v>
                  </c:pt>
                  <c:pt idx="2">
                    <c:v>57.735026918962575</c:v>
                  </c:pt>
                  <c:pt idx="3">
                    <c:v>57.7350269189625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32:$C$35</c:f>
              <c:strCache>
                <c:ptCount val="4"/>
                <c:pt idx="0">
                  <c:v>Veh</c:v>
                </c:pt>
                <c:pt idx="1">
                  <c:v>IL-4 + Veh</c:v>
                </c:pt>
                <c:pt idx="2">
                  <c:v>IL-4 + NAC</c:v>
                </c:pt>
                <c:pt idx="3">
                  <c:v>IL-4 + AAP/NAC</c:v>
                </c:pt>
              </c:strCache>
            </c:strRef>
          </c:cat>
          <c:val>
            <c:numRef>
              <c:f>Sheet1!$D$32:$D$35</c:f>
              <c:numCache>
                <c:formatCode>General</c:formatCode>
                <c:ptCount val="4"/>
                <c:pt idx="0">
                  <c:v>1533.3333333333333</c:v>
                </c:pt>
                <c:pt idx="1">
                  <c:v>1833.3333333333333</c:v>
                </c:pt>
                <c:pt idx="2">
                  <c:v>1933.3333333333333</c:v>
                </c:pt>
                <c:pt idx="3">
                  <c:v>1933.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D4-4621-994B-E9E1C0F888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55296784"/>
        <c:axId val="955304272"/>
      </c:barChart>
      <c:catAx>
        <c:axId val="955296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5304272"/>
        <c:crosses val="autoZero"/>
        <c:auto val="1"/>
        <c:lblAlgn val="ctr"/>
        <c:lblOffset val="100"/>
        <c:noMultiLvlLbl val="0"/>
      </c:catAx>
      <c:valAx>
        <c:axId val="9553042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52967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K$5:$K$7</c:f>
                <c:numCache>
                  <c:formatCode>General</c:formatCode>
                  <c:ptCount val="3"/>
                  <c:pt idx="0">
                    <c:v>2</c:v>
                  </c:pt>
                  <c:pt idx="1">
                    <c:v>1</c:v>
                  </c:pt>
                  <c:pt idx="2">
                    <c:v>1</c:v>
                  </c:pt>
                </c:numCache>
              </c:numRef>
            </c:plus>
            <c:minus>
              <c:numRef>
                <c:f>Sheet1!$K$5:$K$7</c:f>
                <c:numCache>
                  <c:formatCode>General</c:formatCode>
                  <c:ptCount val="3"/>
                  <c:pt idx="0">
                    <c:v>2</c:v>
                  </c:pt>
                  <c:pt idx="1">
                    <c:v>1</c:v>
                  </c:pt>
                  <c:pt idx="2">
                    <c:v>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5:$I$7</c:f>
              <c:strCache>
                <c:ptCount val="3"/>
                <c:pt idx="0">
                  <c:v>Veh</c:v>
                </c:pt>
                <c:pt idx="1">
                  <c:v>NAC</c:v>
                </c:pt>
                <c:pt idx="2">
                  <c:v>AAP/NAC</c:v>
                </c:pt>
              </c:strCache>
            </c:strRef>
          </c:cat>
          <c:val>
            <c:numRef>
              <c:f>Sheet1!$J$5:$J$7</c:f>
              <c:numCache>
                <c:formatCode>General</c:formatCode>
                <c:ptCount val="3"/>
                <c:pt idx="0">
                  <c:v>30</c:v>
                </c:pt>
                <c:pt idx="1">
                  <c:v>31</c:v>
                </c:pt>
                <c:pt idx="2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F5-4C8F-9B86-549408787B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7444424"/>
        <c:axId val="657445408"/>
      </c:barChart>
      <c:catAx>
        <c:axId val="657444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7445408"/>
        <c:crosses val="autoZero"/>
        <c:auto val="1"/>
        <c:lblAlgn val="ctr"/>
        <c:lblOffset val="100"/>
        <c:noMultiLvlLbl val="0"/>
      </c:catAx>
      <c:valAx>
        <c:axId val="6574454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74444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J$19:$J$20</c:f>
                <c:numCache>
                  <c:formatCode>General</c:formatCode>
                  <c:ptCount val="2"/>
                  <c:pt idx="0">
                    <c:v>305.50504633038935</c:v>
                  </c:pt>
                  <c:pt idx="1">
                    <c:v>665.8328118479393</c:v>
                  </c:pt>
                </c:numCache>
              </c:numRef>
            </c:plus>
            <c:minus>
              <c:numRef>
                <c:f>Sheet1!$J$19:$J$20</c:f>
                <c:numCache>
                  <c:formatCode>General</c:formatCode>
                  <c:ptCount val="2"/>
                  <c:pt idx="0">
                    <c:v>305.50504633038935</c:v>
                  </c:pt>
                  <c:pt idx="1">
                    <c:v>665.83281184793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9:$H$20</c:f>
              <c:strCache>
                <c:ptCount val="2"/>
                <c:pt idx="0">
                  <c:v>NAC</c:v>
                </c:pt>
                <c:pt idx="1">
                  <c:v>AAP/NAC</c:v>
                </c:pt>
              </c:strCache>
            </c:strRef>
          </c:cat>
          <c:val>
            <c:numRef>
              <c:f>Sheet1!$I$19:$I$20</c:f>
              <c:numCache>
                <c:formatCode>General</c:formatCode>
                <c:ptCount val="2"/>
                <c:pt idx="0">
                  <c:v>5166.666666666667</c:v>
                </c:pt>
                <c:pt idx="1">
                  <c:v>6533.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76-4CA4-B3FA-E1D85D065E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41272800"/>
        <c:axId val="1541275712"/>
      </c:barChart>
      <c:catAx>
        <c:axId val="154127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41275712"/>
        <c:crosses val="autoZero"/>
        <c:auto val="1"/>
        <c:lblAlgn val="ctr"/>
        <c:lblOffset val="100"/>
        <c:noMultiLvlLbl val="0"/>
      </c:catAx>
      <c:valAx>
        <c:axId val="15412757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4127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19:$G$20</c:f>
                <c:numCache>
                  <c:formatCode>General</c:formatCode>
                  <c:ptCount val="2"/>
                  <c:pt idx="0">
                    <c:v>26.457513110645905</c:v>
                  </c:pt>
                  <c:pt idx="1">
                    <c:v>80.074964876670407</c:v>
                  </c:pt>
                </c:numCache>
              </c:numRef>
            </c:plus>
            <c:minus>
              <c:numRef>
                <c:f>Sheet1!$G$19:$G$20</c:f>
                <c:numCache>
                  <c:formatCode>General</c:formatCode>
                  <c:ptCount val="2"/>
                  <c:pt idx="0">
                    <c:v>26.457513110645905</c:v>
                  </c:pt>
                  <c:pt idx="1">
                    <c:v>80.0749648766704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19:$E$20</c:f>
              <c:strCache>
                <c:ptCount val="2"/>
                <c:pt idx="0">
                  <c:v>NAC</c:v>
                </c:pt>
                <c:pt idx="1">
                  <c:v>AAP/NAC</c:v>
                </c:pt>
              </c:strCache>
            </c:strRef>
          </c:cat>
          <c:val>
            <c:numRef>
              <c:f>Sheet1!$F$19:$F$20</c:f>
              <c:numCache>
                <c:formatCode>General</c:formatCode>
                <c:ptCount val="2"/>
                <c:pt idx="0">
                  <c:v>860</c:v>
                </c:pt>
                <c:pt idx="1">
                  <c:v>9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41-469C-8890-83E7BB29EC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48784624"/>
        <c:axId val="1548781296"/>
      </c:barChart>
      <c:catAx>
        <c:axId val="1548784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48781296"/>
        <c:crosses val="autoZero"/>
        <c:auto val="1"/>
        <c:lblAlgn val="ctr"/>
        <c:lblOffset val="100"/>
        <c:noMultiLvlLbl val="0"/>
      </c:catAx>
      <c:valAx>
        <c:axId val="1548781296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487846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M$6:$M$7</c:f>
                <c:numCache>
                  <c:formatCode>General</c:formatCode>
                  <c:ptCount val="2"/>
                  <c:pt idx="0">
                    <c:v>230</c:v>
                  </c:pt>
                  <c:pt idx="1">
                    <c:v>130</c:v>
                  </c:pt>
                </c:numCache>
              </c:numRef>
            </c:plus>
            <c:minus>
              <c:numRef>
                <c:f>Sheet1!$M$6:$M$7</c:f>
                <c:numCache>
                  <c:formatCode>General</c:formatCode>
                  <c:ptCount val="2"/>
                  <c:pt idx="0">
                    <c:v>230</c:v>
                  </c:pt>
                  <c:pt idx="1">
                    <c:v>13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K$6:$K$7</c:f>
              <c:strCache>
                <c:ptCount val="2"/>
                <c:pt idx="0">
                  <c:v>NAC</c:v>
                </c:pt>
                <c:pt idx="1">
                  <c:v>AAP/NAC</c:v>
                </c:pt>
              </c:strCache>
            </c:strRef>
          </c:cat>
          <c:val>
            <c:numRef>
              <c:f>Sheet1!$L$6:$L$7</c:f>
              <c:numCache>
                <c:formatCode>General</c:formatCode>
                <c:ptCount val="2"/>
                <c:pt idx="0">
                  <c:v>1035</c:v>
                </c:pt>
                <c:pt idx="1">
                  <c:v>5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AA-40C5-B0BD-7B343211EE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86134032"/>
        <c:axId val="1486134864"/>
      </c:barChart>
      <c:catAx>
        <c:axId val="1486134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86134864"/>
        <c:crosses val="autoZero"/>
        <c:auto val="1"/>
        <c:lblAlgn val="ctr"/>
        <c:lblOffset val="100"/>
        <c:noMultiLvlLbl val="0"/>
      </c:catAx>
      <c:valAx>
        <c:axId val="14861348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86134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A69FE5-726E-7D0C-C17B-E207E354D2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154EBC-D08A-1CCB-EE85-CEE5B3EA7DB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E1EF35-B1D8-7F17-9169-E92F9F2A6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09699-897D-41AC-B86F-AEDEFBAA3F52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9C0F39-9AFB-3F78-B65B-D0D32F0F7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A04BC8-9791-E648-B534-C521DDF825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DE363-7595-4EAC-8F6F-7100EFB36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95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7BF98-2DCA-CC5D-883C-EC4CB87DD1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52CD0B-6410-76FC-C46B-30B3F5EA77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71CA87-BB4C-248D-B1EC-90F425ACA9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09699-897D-41AC-B86F-AEDEFBAA3F52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3C27E7-6C57-62D1-CBE8-8538B5B3C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C6D028-5E3E-F39B-26B8-73C5B6344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DE363-7595-4EAC-8F6F-7100EFB36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667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F9DDC2-FBFC-4F5D-F225-90024E402B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1B774E-2C7C-B874-BD23-2DD96D37F7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7658A5-D83E-56A2-DF21-868C8EF1D7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09699-897D-41AC-B86F-AEDEFBAA3F52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02024D-4D67-D1E4-FD39-B3D6ABE416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D33BF0-EDF8-668D-7E8C-A988CC2BB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DE363-7595-4EAC-8F6F-7100EFB36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371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4343A5-854A-1B2A-9AAF-2205AFC6F3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B46550-CDA6-EDB1-A3A7-8162F65E90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EBAD31-85F5-CBF2-201C-36934D91F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09699-897D-41AC-B86F-AEDEFBAA3F52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5BFFB6-8579-6CBD-AAE3-D93E14B077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B50096-43F0-9C16-FC9B-543C6C979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DE363-7595-4EAC-8F6F-7100EFB36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992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5FC3A1-29E1-03DD-E1F7-1322CDB2B6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3AB7C1-0EDB-A34A-5B18-1CEE690FBB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3A84A3-DA70-411E-2DC5-839872B206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09699-897D-41AC-B86F-AEDEFBAA3F52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3384CB-0F00-4300-CB2C-737AB51DD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8C22D5-D63D-4227-24A5-28647B5BF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DE363-7595-4EAC-8F6F-7100EFB36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538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C44409-83FE-6201-3C26-AD58FF5701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2E7D4A-1C60-3056-4717-BFABBFE647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422F39-FCC3-B27E-ECAC-0652799FD6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2AD737-95BE-C27E-FAE8-FBD471FFBB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09699-897D-41AC-B86F-AEDEFBAA3F52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A70D70-4554-FD9E-F3E9-F852A1393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5CD49B-E703-433E-DCA1-FC08A9B37D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DE363-7595-4EAC-8F6F-7100EFB36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377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73499C-BB82-A778-2E05-60E01CBB5D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85114D-A0E4-DA8B-E39D-9EEAB1FE85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55628E-DCAB-E4AA-49A3-AB5EA6EC69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CA3B075-E731-2AD5-34A1-163854B221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918E9C1-FB87-DA5F-3BF1-9DCB77D917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259BBE-162B-A150-DAF4-5CD1AD8B7C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09699-897D-41AC-B86F-AEDEFBAA3F52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7836E56-74EF-A3E0-9BB1-7A493F553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8FB150-F678-AAF7-6B03-9CBFCE234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DE363-7595-4EAC-8F6F-7100EFB36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965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1F9CCD-A99A-19D2-5E84-AFFBF1446B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821879F-3115-2E4B-0A96-78541566A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09699-897D-41AC-B86F-AEDEFBAA3F52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395D634-F29D-4528-058A-A051C35070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F21C7E7-430F-3B25-20B9-8CDF953CC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DE363-7595-4EAC-8F6F-7100EFB36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995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C841B82-4731-8B19-1861-902E4FBB0E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09699-897D-41AC-B86F-AEDEFBAA3F52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8C10AD3-811A-6CF1-C45B-DC185D15B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DB2C184-106C-9BA6-CBC4-895ECF25F8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DE363-7595-4EAC-8F6F-7100EFB36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705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A13076-3C87-10C1-0530-1E2B775251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7AD502-FBCD-1360-EE41-8E54554873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890ACF-E171-5643-F9D7-B8A7AAB039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41DDAC-DA92-F1B3-E72A-D0392A56FE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09699-897D-41AC-B86F-AEDEFBAA3F52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2C0B69-32CF-6524-681F-68C5F292D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C02893-A5BF-DCC5-C3B1-5BCB9E7C2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DE363-7595-4EAC-8F6F-7100EFB36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2627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69FE30-290D-D276-2476-2F591629A5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0D42047-8BD5-9866-B034-030C4AA5E1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C88374-CFE4-E437-978A-1805E6698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119CFD-931F-7263-5A56-EF9826F1B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09699-897D-41AC-B86F-AEDEFBAA3F52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2420E3-83D3-CB23-FBE3-E23BA5778B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DE62AC-7232-2672-9724-11527DC4D5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DE363-7595-4EAC-8F6F-7100EFB36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885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6F68AF-EFAB-0685-B1B2-A244F91AC7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8864C5-C3CC-7208-CFB5-19161A0A72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C45E64-240D-7A8C-A923-CC0D1A1BA3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D09699-897D-41AC-B86F-AEDEFBAA3F52}" type="datetimeFigureOut">
              <a:rPr lang="en-US" smtClean="0"/>
              <a:t>9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428BF5-873D-42A5-DA88-B2069FC49C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7F76C9-877D-ABF2-2855-9975E15FA3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DE363-7595-4EAC-8F6F-7100EFB363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0995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1.xml"/><Relationship Id="rId4" Type="http://schemas.openxmlformats.org/officeDocument/2006/relationships/chart" Target="../charts/chart10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5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6.xml"/><Relationship Id="rId4" Type="http://schemas.openxmlformats.org/officeDocument/2006/relationships/image" Target="../media/image3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0C3F03-F37A-E15D-E0C5-CFDFDEBBAFF6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l Figur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D716AA-58A9-4E7D-95E0-9AC770FCDC1C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621709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659CEC55-9E29-C363-C4C0-E4637E3C0053}"/>
              </a:ext>
            </a:extLst>
          </p:cNvPr>
          <p:cNvGraphicFramePr>
            <a:graphicFrameLocks/>
          </p:cNvGraphicFramePr>
          <p:nvPr/>
        </p:nvGraphicFramePr>
        <p:xfrm>
          <a:off x="3810000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40A008B-20C8-9978-B806-526CC6FC7869}"/>
              </a:ext>
            </a:extLst>
          </p:cNvPr>
          <p:cNvSpPr txBox="1"/>
          <p:nvPr/>
        </p:nvSpPr>
        <p:spPr>
          <a:xfrm>
            <a:off x="5267325" y="1295400"/>
            <a:ext cx="2771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206 MFI values</a:t>
            </a:r>
          </a:p>
        </p:txBody>
      </p:sp>
    </p:spTree>
    <p:extLst>
      <p:ext uri="{BB962C8B-B14F-4D97-AF65-F5344CB8AC3E}">
        <p14:creationId xmlns:p14="http://schemas.microsoft.com/office/powerpoint/2010/main" val="409820911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AD4B01B-DBEF-5F6E-6229-C50A763F0B26}"/>
              </a:ext>
            </a:extLst>
          </p:cNvPr>
          <p:cNvSpPr txBox="1"/>
          <p:nvPr/>
        </p:nvSpPr>
        <p:spPr>
          <a:xfrm>
            <a:off x="1085850" y="333375"/>
            <a:ext cx="87915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5.  4T1 tumors were digested into single cell suspension and analyzed using </a:t>
            </a:r>
            <a:r>
              <a:rPr lang="en-US" dirty="0" err="1"/>
              <a:t>Cytek</a:t>
            </a:r>
            <a:r>
              <a:rPr lang="en-US" dirty="0"/>
              <a:t> Aurora.  Gating was for live cells, CD45+, F4/80+ macrophages.  N = 2 per condition, * ≤ 0.05. Error bars represent</a:t>
            </a:r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dirty="0"/>
              <a:t>± 1 SEM</a:t>
            </a:r>
          </a:p>
        </p:txBody>
      </p:sp>
    </p:spTree>
    <p:extLst>
      <p:ext uri="{BB962C8B-B14F-4D97-AF65-F5344CB8AC3E}">
        <p14:creationId xmlns:p14="http://schemas.microsoft.com/office/powerpoint/2010/main" val="68536964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2A8A03E-5AD4-1F4A-004D-F7AF7159568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758" t="7651" b="30399"/>
          <a:stretch/>
        </p:blipFill>
        <p:spPr>
          <a:xfrm>
            <a:off x="3101007" y="427382"/>
            <a:ext cx="2232607" cy="216673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D882640-1CE4-58F7-98E4-7A7F671DC63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758" t="7651" b="30399"/>
          <a:stretch/>
        </p:blipFill>
        <p:spPr>
          <a:xfrm>
            <a:off x="868399" y="427382"/>
            <a:ext cx="2232608" cy="216673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72A7602-2B3D-0F78-2742-258A301CC387}"/>
              </a:ext>
            </a:extLst>
          </p:cNvPr>
          <p:cNvSpPr txBox="1"/>
          <p:nvPr/>
        </p:nvSpPr>
        <p:spPr>
          <a:xfrm>
            <a:off x="1252332" y="2524539"/>
            <a:ext cx="12324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D11b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67BBA471-EF88-DE43-E542-21C288803B21}"/>
              </a:ext>
            </a:extLst>
          </p:cNvPr>
          <p:cNvCxnSpPr/>
          <p:nvPr/>
        </p:nvCxnSpPr>
        <p:spPr>
          <a:xfrm>
            <a:off x="1868557" y="2678427"/>
            <a:ext cx="325009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C14EE69A-825E-9870-BB11-9959E2B91343}"/>
              </a:ext>
            </a:extLst>
          </p:cNvPr>
          <p:cNvSpPr txBox="1"/>
          <p:nvPr/>
        </p:nvSpPr>
        <p:spPr>
          <a:xfrm rot="16200000">
            <a:off x="166483" y="1673759"/>
            <a:ext cx="12324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F4/80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D88A83EF-650B-E3FC-BCA4-E7653694F454}"/>
              </a:ext>
            </a:extLst>
          </p:cNvPr>
          <p:cNvCxnSpPr/>
          <p:nvPr/>
        </p:nvCxnSpPr>
        <p:spPr>
          <a:xfrm flipV="1">
            <a:off x="781050" y="647700"/>
            <a:ext cx="0" cy="11334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5364EDE7-F09C-6D19-8C10-106087E0CF9D}"/>
              </a:ext>
            </a:extLst>
          </p:cNvPr>
          <p:cNvGraphicFramePr>
            <a:graphicFrameLocks/>
          </p:cNvGraphicFramePr>
          <p:nvPr/>
        </p:nvGraphicFramePr>
        <p:xfrm>
          <a:off x="5905500" y="647700"/>
          <a:ext cx="2994995" cy="19038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677C9E44-CDF0-809B-C67E-1B376080FBC7}"/>
              </a:ext>
            </a:extLst>
          </p:cNvPr>
          <p:cNvSpPr txBox="1"/>
          <p:nvPr/>
        </p:nvSpPr>
        <p:spPr>
          <a:xfrm rot="16200000">
            <a:off x="4404539" y="1220487"/>
            <a:ext cx="27908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%CD11B+/F4/80+ </a:t>
            </a:r>
          </a:p>
          <a:p>
            <a:pPr algn="ctr"/>
            <a:r>
              <a:rPr lang="en-US" sz="1200" dirty="0"/>
              <a:t>of CD45+ cells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4672A443-B699-20DD-933A-0DD6A146A708}"/>
              </a:ext>
            </a:extLst>
          </p:cNvPr>
          <p:cNvCxnSpPr/>
          <p:nvPr/>
        </p:nvCxnSpPr>
        <p:spPr>
          <a:xfrm>
            <a:off x="6800850" y="762000"/>
            <a:ext cx="124777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7B8D3D18-9273-3A09-3619-4761B746906A}"/>
              </a:ext>
            </a:extLst>
          </p:cNvPr>
          <p:cNvSpPr txBox="1"/>
          <p:nvPr/>
        </p:nvSpPr>
        <p:spPr>
          <a:xfrm>
            <a:off x="7114401" y="509200"/>
            <a:ext cx="1057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 = 0.06</a:t>
            </a:r>
          </a:p>
        </p:txBody>
      </p:sp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52E3C534-8A4E-8339-B5F6-9C207CD0381C}"/>
              </a:ext>
            </a:extLst>
          </p:cNvPr>
          <p:cNvGraphicFramePr>
            <a:graphicFrameLocks/>
          </p:cNvGraphicFramePr>
          <p:nvPr/>
        </p:nvGraphicFramePr>
        <p:xfrm>
          <a:off x="8900495" y="647699"/>
          <a:ext cx="2994995" cy="19038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A5D06B57-34A4-CDFE-B2E2-EF05E446D936}"/>
              </a:ext>
            </a:extLst>
          </p:cNvPr>
          <p:cNvCxnSpPr/>
          <p:nvPr/>
        </p:nvCxnSpPr>
        <p:spPr>
          <a:xfrm>
            <a:off x="9833171" y="762000"/>
            <a:ext cx="124777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BD582498-6A7F-D9C2-6DC1-51A5C122D089}"/>
              </a:ext>
            </a:extLst>
          </p:cNvPr>
          <p:cNvSpPr txBox="1"/>
          <p:nvPr/>
        </p:nvSpPr>
        <p:spPr>
          <a:xfrm>
            <a:off x="10353675" y="509200"/>
            <a:ext cx="1057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F0B3825-6843-2838-D748-DF1512424FB5}"/>
              </a:ext>
            </a:extLst>
          </p:cNvPr>
          <p:cNvSpPr txBox="1"/>
          <p:nvPr/>
        </p:nvSpPr>
        <p:spPr>
          <a:xfrm>
            <a:off x="1752408" y="78953"/>
            <a:ext cx="1304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A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4427F02-3155-4173-032A-B365B9AE917E}"/>
              </a:ext>
            </a:extLst>
          </p:cNvPr>
          <p:cNvSpPr txBox="1"/>
          <p:nvPr/>
        </p:nvSpPr>
        <p:spPr>
          <a:xfrm>
            <a:off x="3773267" y="88828"/>
            <a:ext cx="1304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AP/NAC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477A57B-3773-9928-0565-39B1BB277413}"/>
              </a:ext>
            </a:extLst>
          </p:cNvPr>
          <p:cNvSpPr txBox="1"/>
          <p:nvPr/>
        </p:nvSpPr>
        <p:spPr>
          <a:xfrm>
            <a:off x="7171744" y="88828"/>
            <a:ext cx="1370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T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E33F94B-3FBF-A42F-485F-7E30A1BEA844}"/>
              </a:ext>
            </a:extLst>
          </p:cNvPr>
          <p:cNvSpPr txBox="1"/>
          <p:nvPr/>
        </p:nvSpPr>
        <p:spPr>
          <a:xfrm>
            <a:off x="9984087" y="90663"/>
            <a:ext cx="1370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F43.fgf4</a:t>
            </a:r>
          </a:p>
        </p:txBody>
      </p:sp>
    </p:spTree>
    <p:extLst>
      <p:ext uri="{BB962C8B-B14F-4D97-AF65-F5344CB8AC3E}">
        <p14:creationId xmlns:p14="http://schemas.microsoft.com/office/powerpoint/2010/main" val="371744924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423CE52-97A2-319B-F227-ECFD88E5FBAD}"/>
              </a:ext>
            </a:extLst>
          </p:cNvPr>
          <p:cNvSpPr txBox="1"/>
          <p:nvPr/>
        </p:nvSpPr>
        <p:spPr>
          <a:xfrm>
            <a:off x="539827" y="330506"/>
            <a:ext cx="110499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6.  Digested tumors were analyzed for TAM content.  Shown on left is gating strategy for 4T1 tumors.  Shown on right is average macrophages, N=3/condition. </a:t>
            </a:r>
          </a:p>
        </p:txBody>
      </p:sp>
    </p:spTree>
    <p:extLst>
      <p:ext uri="{BB962C8B-B14F-4D97-AF65-F5344CB8AC3E}">
        <p14:creationId xmlns:p14="http://schemas.microsoft.com/office/powerpoint/2010/main" val="332842913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55A2AE-BD73-B8EA-1D7E-48AAB2D202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-1326"/>
            <a:ext cx="10515600" cy="1325563"/>
          </a:xfrm>
        </p:spPr>
        <p:txBody>
          <a:bodyPr/>
          <a:lstStyle/>
          <a:p>
            <a:r>
              <a:rPr lang="en-US" dirty="0"/>
              <a:t>Supplemental methods: Primer pairs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AE2F784A-6975-8AB7-0294-A8A62CD3A37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016401573"/>
              </p:ext>
            </p:extLst>
          </p:nvPr>
        </p:nvGraphicFramePr>
        <p:xfrm>
          <a:off x="3181058" y="1131290"/>
          <a:ext cx="4521200" cy="5486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42198">
                  <a:extLst>
                    <a:ext uri="{9D8B030D-6E8A-4147-A177-3AD203B41FA5}">
                      <a16:colId xmlns:a16="http://schemas.microsoft.com/office/drawing/2014/main" val="1099845666"/>
                    </a:ext>
                  </a:extLst>
                </a:gridCol>
                <a:gridCol w="3379002">
                  <a:extLst>
                    <a:ext uri="{9D8B030D-6E8A-4147-A177-3AD203B41FA5}">
                      <a16:colId xmlns:a16="http://schemas.microsoft.com/office/drawing/2014/main" val="2335239886"/>
                    </a:ext>
                  </a:extLst>
                </a:gridCol>
              </a:tblGrid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 Forward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l-NL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 AAC TGG CAG AAG AG </a:t>
                      </a:r>
                      <a:endParaRPr lang="nl-NL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6773761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 Reverse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CA TAG AAC TGA TGA GAG G</a:t>
                      </a:r>
                      <a:endParaRPr lang="sv-SE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2393279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ginase Forward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 ACA GCA GAG </a:t>
                      </a:r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TG AAG AG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08972749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ginase Reverse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 GAG </a:t>
                      </a:r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AG GCG TTT GC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94029879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OS forward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 CAG CAC TTG GAT CAG GAA CCT G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5257820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OS reverse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 AGT AGC CTG TGT GCA CCT GGA A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43314192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2-p40 Forward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 AGC ACG GCA </a:t>
                      </a:r>
                      <a:r>
                        <a:rPr lang="en-US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AA TA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9822452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2-p40 Reverse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AC TTG AGG GAG AAG TAG GAA TGG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25768019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06 Forward</a:t>
                      </a:r>
                      <a:endParaRPr lang="en-US" sz="8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TTGCCTTTCCCAGTCTC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3714928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06 Reverse</a:t>
                      </a:r>
                      <a:endParaRPr lang="en-US" sz="8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CACCCAGCGGAATTT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64032970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orwar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GGCCTTCCGTGTTCCT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665048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b="0" i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vers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CATCATACTTGGCAGGTTTCT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733078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M1 forwar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TCTCCAGTGTAGCCATCCTT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7266499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M1 revers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GGGTACAAGATCCCTGA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48260623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ZZ1 forwar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ATGACTGCTACTGGGTG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95902769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ZZ1 revers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AACGAGTAAGCACAGGCA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16193415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24 forwar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CTGTGACCATCCCCTCAT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8884146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24 forwar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ATGTGCCTCTGAACCCAC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3761157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RF4 forwar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CAACAAGCTAGAAAG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76313191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800" b="0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RF4 revers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CTGAGGGTCTGGAAACT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011521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84019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39DC3A8B-6469-8ABC-1CE0-6FE3FA103AB9}"/>
              </a:ext>
            </a:extLst>
          </p:cNvPr>
          <p:cNvGraphicFramePr>
            <a:graphicFrameLocks/>
          </p:cNvGraphicFramePr>
          <p:nvPr/>
        </p:nvGraphicFramePr>
        <p:xfrm>
          <a:off x="1523999" y="193357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ACE970F5-3DEE-A475-3C03-38391298E060}"/>
              </a:ext>
            </a:extLst>
          </p:cNvPr>
          <p:cNvSpPr txBox="1"/>
          <p:nvPr/>
        </p:nvSpPr>
        <p:spPr>
          <a:xfrm rot="16200000">
            <a:off x="785424" y="2709475"/>
            <a:ext cx="1162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rginase (MFI)</a:t>
            </a: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47D9CD31-14BE-43BB-D5C9-A7388817B78E}"/>
              </a:ext>
            </a:extLst>
          </p:cNvPr>
          <p:cNvGraphicFramePr>
            <a:graphicFrameLocks/>
          </p:cNvGraphicFramePr>
          <p:nvPr/>
        </p:nvGraphicFramePr>
        <p:xfrm>
          <a:off x="6686550" y="193357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AB6F7BD-782A-B42D-F32E-14FB0E926AA2}"/>
              </a:ext>
            </a:extLst>
          </p:cNvPr>
          <p:cNvSpPr txBox="1"/>
          <p:nvPr/>
        </p:nvSpPr>
        <p:spPr>
          <a:xfrm rot="16200000">
            <a:off x="5967026" y="2709475"/>
            <a:ext cx="1162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D-L2 (MFI)</a:t>
            </a:r>
          </a:p>
        </p:txBody>
      </p:sp>
    </p:spTree>
    <p:extLst>
      <p:ext uri="{BB962C8B-B14F-4D97-AF65-F5344CB8AC3E}">
        <p14:creationId xmlns:p14="http://schemas.microsoft.com/office/powerpoint/2010/main" val="1004720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F9213CA-47A7-ADCC-813B-1B5D4CBAEB41}"/>
              </a:ext>
            </a:extLst>
          </p:cNvPr>
          <p:cNvSpPr txBox="1"/>
          <p:nvPr/>
        </p:nvSpPr>
        <p:spPr>
          <a:xfrm>
            <a:off x="914400" y="657225"/>
            <a:ext cx="1103947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1.  Bone marrow derived macrophages (BMDM) were either left unstimulated (M0), or stimulated for 24 hours with IFN gamma (20 ng/mL) and LPS (100 ng/mL) (M1). EF43.fgf4 breast cancer cells were included in co-culture for 24 hours, and analyses for protein expression was performed via flow cytometry, gating for CD45+/F480+ tumor cells. Error bars represent ± 1 SEM </a:t>
            </a:r>
          </a:p>
        </p:txBody>
      </p:sp>
    </p:spTree>
    <p:extLst>
      <p:ext uri="{BB962C8B-B14F-4D97-AF65-F5344CB8AC3E}">
        <p14:creationId xmlns:p14="http://schemas.microsoft.com/office/powerpoint/2010/main" val="14485168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E51F6DF6-03F8-6230-37CC-70430B46B32E}"/>
              </a:ext>
            </a:extLst>
          </p:cNvPr>
          <p:cNvGraphicFramePr>
            <a:graphicFrameLocks/>
          </p:cNvGraphicFramePr>
          <p:nvPr/>
        </p:nvGraphicFramePr>
        <p:xfrm>
          <a:off x="1219202" y="112394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A553E37-0B24-92CE-C6AE-6513317393CD}"/>
              </a:ext>
            </a:extLst>
          </p:cNvPr>
          <p:cNvSpPr txBox="1"/>
          <p:nvPr/>
        </p:nvSpPr>
        <p:spPr>
          <a:xfrm rot="16200000">
            <a:off x="499678" y="2223697"/>
            <a:ext cx="1162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D-L1 (MFI)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6AFDED2E-65B1-A036-44B4-35F54564FE80}"/>
              </a:ext>
            </a:extLst>
          </p:cNvPr>
          <p:cNvGraphicFramePr>
            <a:graphicFrameLocks/>
          </p:cNvGraphicFramePr>
          <p:nvPr/>
        </p:nvGraphicFramePr>
        <p:xfrm>
          <a:off x="6943726" y="112394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0DB008A7-77D0-1D57-FE10-9FFCBA5A16C5}"/>
              </a:ext>
            </a:extLst>
          </p:cNvPr>
          <p:cNvSpPr txBox="1"/>
          <p:nvPr/>
        </p:nvSpPr>
        <p:spPr>
          <a:xfrm rot="16200000">
            <a:off x="6224202" y="2223698"/>
            <a:ext cx="1162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HC I (MFI)</a:t>
            </a:r>
          </a:p>
        </p:txBody>
      </p:sp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4C28F8E4-C76A-62B8-B63F-F9D153D6F7FC}"/>
              </a:ext>
            </a:extLst>
          </p:cNvPr>
          <p:cNvGraphicFramePr>
            <a:graphicFrameLocks/>
          </p:cNvGraphicFramePr>
          <p:nvPr/>
        </p:nvGraphicFramePr>
        <p:xfrm>
          <a:off x="3810000" y="407806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55AC74C9-3236-21A8-823A-1A2C3BE72156}"/>
              </a:ext>
            </a:extLst>
          </p:cNvPr>
          <p:cNvSpPr txBox="1"/>
          <p:nvPr/>
        </p:nvSpPr>
        <p:spPr>
          <a:xfrm rot="16200000">
            <a:off x="3090476" y="5147876"/>
            <a:ext cx="1162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NOS (MFI)</a:t>
            </a:r>
          </a:p>
        </p:txBody>
      </p:sp>
    </p:spTree>
    <p:extLst>
      <p:ext uri="{BB962C8B-B14F-4D97-AF65-F5344CB8AC3E}">
        <p14:creationId xmlns:p14="http://schemas.microsoft.com/office/powerpoint/2010/main" val="10061162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C2BAA61-ABB2-0F29-4A9A-17D46C260E19}"/>
              </a:ext>
            </a:extLst>
          </p:cNvPr>
          <p:cNvSpPr txBox="1"/>
          <p:nvPr/>
        </p:nvSpPr>
        <p:spPr>
          <a:xfrm>
            <a:off x="914400" y="657225"/>
            <a:ext cx="1103947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2.  Bone marrow derived macrophages (BMDM) were either left unstimulated (</a:t>
            </a:r>
            <a:r>
              <a:rPr lang="en-US" dirty="0" err="1"/>
              <a:t>Veh</a:t>
            </a:r>
            <a:r>
              <a:rPr lang="en-US" dirty="0"/>
              <a:t>), or stimulated for 24 hours with IL-4 (20 ng/mL).  EF43.fgf4 breast cancer cells were included in co-culture for 24 hours, and analyses for protein expression was performed via flow cytometry, gating for CD45+/F480+ tumor cells. Error bars represent</a:t>
            </a:r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dirty="0"/>
              <a:t>± 1 SEM </a:t>
            </a:r>
          </a:p>
        </p:txBody>
      </p:sp>
    </p:spTree>
    <p:extLst>
      <p:ext uri="{BB962C8B-B14F-4D97-AF65-F5344CB8AC3E}">
        <p14:creationId xmlns:p14="http://schemas.microsoft.com/office/powerpoint/2010/main" val="24093985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E80F17A-7DC6-9BDF-6E2B-B9E84984BA72}"/>
              </a:ext>
            </a:extLst>
          </p:cNvPr>
          <p:cNvGrpSpPr/>
          <p:nvPr/>
        </p:nvGrpSpPr>
        <p:grpSpPr>
          <a:xfrm>
            <a:off x="932865" y="1801076"/>
            <a:ext cx="9724152" cy="2280765"/>
            <a:chOff x="151815" y="4344251"/>
            <a:chExt cx="9724152" cy="228076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C212E61B-3775-BE24-63F0-C0BC677F1C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589" b="8940"/>
            <a:stretch/>
          </p:blipFill>
          <p:spPr>
            <a:xfrm>
              <a:off x="397211" y="4610721"/>
              <a:ext cx="1787859" cy="1771106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26F852F-36F7-0928-599E-76E6DA3491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623" b="7838"/>
            <a:stretch/>
          </p:blipFill>
          <p:spPr>
            <a:xfrm>
              <a:off x="2316033" y="4646645"/>
              <a:ext cx="1683500" cy="1688555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68CD3A3-E33B-762D-410B-7EEE95CC9D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640" b="7838"/>
            <a:stretch/>
          </p:blipFill>
          <p:spPr>
            <a:xfrm>
              <a:off x="4243813" y="4646645"/>
              <a:ext cx="1711358" cy="1735182"/>
            </a:xfrm>
            <a:prstGeom prst="rect">
              <a:avLst/>
            </a:prstGeom>
          </p:spPr>
        </p:pic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CBE7BA60-CDDB-9196-C6CA-FBDFB8A6E83F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6171594" y="4554124"/>
            <a:ext cx="3704373" cy="19323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39D3708E-43D6-CC12-5FCA-C7AB3F0CEB71}"/>
                </a:ext>
              </a:extLst>
            </p:cNvPr>
            <p:cNvCxnSpPr/>
            <p:nvPr/>
          </p:nvCxnSpPr>
          <p:spPr>
            <a:xfrm flipH="1">
              <a:off x="8164286" y="4620316"/>
              <a:ext cx="933061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11960A1-22A4-E823-EAD4-DCB8784E9282}"/>
                </a:ext>
              </a:extLst>
            </p:cNvPr>
            <p:cNvSpPr txBox="1"/>
            <p:nvPr/>
          </p:nvSpPr>
          <p:spPr>
            <a:xfrm>
              <a:off x="8486394" y="4344251"/>
              <a:ext cx="4772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E6F4968-738A-BC8A-F1ED-8BC3CF820EA7}"/>
                </a:ext>
              </a:extLst>
            </p:cNvPr>
            <p:cNvSpPr txBox="1"/>
            <p:nvPr/>
          </p:nvSpPr>
          <p:spPr>
            <a:xfrm rot="16200000">
              <a:off x="5412282" y="5193869"/>
              <a:ext cx="1371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% tumor cell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34B0AFC-EA9E-8DDC-3108-72C9BE4734A7}"/>
                </a:ext>
              </a:extLst>
            </p:cNvPr>
            <p:cNvSpPr txBox="1"/>
            <p:nvPr/>
          </p:nvSpPr>
          <p:spPr>
            <a:xfrm rot="16200000">
              <a:off x="-143883" y="5628067"/>
              <a:ext cx="8683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CD45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8D8F05B-ABB8-2BE0-D5BA-576495941F94}"/>
                </a:ext>
              </a:extLst>
            </p:cNvPr>
            <p:cNvSpPr txBox="1"/>
            <p:nvPr/>
          </p:nvSpPr>
          <p:spPr>
            <a:xfrm>
              <a:off x="753445" y="6348017"/>
              <a:ext cx="8683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F4/80</a:t>
              </a:r>
            </a:p>
          </p:txBody>
        </p: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C26661B0-6803-36C0-70FE-D289FF323CEB}"/>
                </a:ext>
              </a:extLst>
            </p:cNvPr>
            <p:cNvCxnSpPr/>
            <p:nvPr/>
          </p:nvCxnSpPr>
          <p:spPr>
            <a:xfrm>
              <a:off x="1291140" y="6486517"/>
              <a:ext cx="4338045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6636B255-FC79-8B06-5A35-14BFEA074BD0}"/>
                </a:ext>
              </a:extLst>
            </p:cNvPr>
            <p:cNvCxnSpPr/>
            <p:nvPr/>
          </p:nvCxnSpPr>
          <p:spPr>
            <a:xfrm flipV="1">
              <a:off x="290315" y="4981575"/>
              <a:ext cx="12670" cy="67627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7417759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12054AB-73AC-0BF6-58F9-6E3B83B7D9B0}"/>
              </a:ext>
            </a:extLst>
          </p:cNvPr>
          <p:cNvSpPr txBox="1"/>
          <p:nvPr/>
        </p:nvSpPr>
        <p:spPr>
          <a:xfrm>
            <a:off x="323849" y="238125"/>
            <a:ext cx="1176337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3.  Selective cytotoxicity of AAP/NAC towards tumor cells relative to macrophages in M2 macrophages.  Bone marrow derived macrophages (BMDM) were polarized for 24 hours towards M2 phenotype using IL-4.  The following day, LLC-</a:t>
            </a:r>
            <a:r>
              <a:rPr lang="en-US" dirty="0" err="1"/>
              <a:t>luc</a:t>
            </a:r>
            <a:r>
              <a:rPr lang="en-US" dirty="0"/>
              <a:t> cells were added, and the co-culture was treated overnight with </a:t>
            </a:r>
            <a:r>
              <a:rPr lang="en-US" dirty="0" err="1"/>
              <a:t>Veh</a:t>
            </a:r>
            <a:r>
              <a:rPr lang="en-US" dirty="0"/>
              <a:t>, AAP, and/or NAC.  Cells were analyzed using flow cytometry, and prevalence of CD45+/F4/80+ BMDM was assessed relative to tumor cells. N = 3 per condition. * ≤ 0.05</a:t>
            </a:r>
          </a:p>
        </p:txBody>
      </p:sp>
    </p:spTree>
    <p:extLst>
      <p:ext uri="{BB962C8B-B14F-4D97-AF65-F5344CB8AC3E}">
        <p14:creationId xmlns:p14="http://schemas.microsoft.com/office/powerpoint/2010/main" val="4176734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26EFDC49-F2E7-4242-8ACE-B2E82BFE170A}"/>
              </a:ext>
            </a:extLst>
          </p:cNvPr>
          <p:cNvGraphicFramePr>
            <a:graphicFrameLocks/>
          </p:cNvGraphicFramePr>
          <p:nvPr/>
        </p:nvGraphicFramePr>
        <p:xfrm>
          <a:off x="5410200" y="193357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9EBB7EE5-C1D2-A9AD-A791-4DC688286B59}"/>
              </a:ext>
            </a:extLst>
          </p:cNvPr>
          <p:cNvGraphicFramePr>
            <a:graphicFrameLocks/>
          </p:cNvGraphicFramePr>
          <p:nvPr/>
        </p:nvGraphicFramePr>
        <p:xfrm>
          <a:off x="1339214" y="1933574"/>
          <a:ext cx="3528061" cy="2743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C48BEE68-9948-950F-2BC4-CCF3A62B45EA}"/>
              </a:ext>
            </a:extLst>
          </p:cNvPr>
          <p:cNvCxnSpPr/>
          <p:nvPr/>
        </p:nvCxnSpPr>
        <p:spPr>
          <a:xfrm>
            <a:off x="6886575" y="1828800"/>
            <a:ext cx="192405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D75C63E7-F1AF-6424-8A9F-756D14F50AF3}"/>
              </a:ext>
            </a:extLst>
          </p:cNvPr>
          <p:cNvSpPr txBox="1"/>
          <p:nvPr/>
        </p:nvSpPr>
        <p:spPr>
          <a:xfrm>
            <a:off x="7734300" y="1495424"/>
            <a:ext cx="1076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10036BD-D44D-E8EC-C59F-A3EC9A4644E8}"/>
              </a:ext>
            </a:extLst>
          </p:cNvPr>
          <p:cNvSpPr txBox="1"/>
          <p:nvPr/>
        </p:nvSpPr>
        <p:spPr>
          <a:xfrm rot="16200000">
            <a:off x="4587359" y="2686050"/>
            <a:ext cx="1276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64 MF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B43322A-54B8-A156-76C1-B4C842A72575}"/>
              </a:ext>
            </a:extLst>
          </p:cNvPr>
          <p:cNvSpPr txBox="1"/>
          <p:nvPr/>
        </p:nvSpPr>
        <p:spPr>
          <a:xfrm rot="16200000">
            <a:off x="537566" y="2686050"/>
            <a:ext cx="1276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80 MFI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274832C-1264-AD71-F8BD-0B882ABF2CCD}"/>
              </a:ext>
            </a:extLst>
          </p:cNvPr>
          <p:cNvCxnSpPr/>
          <p:nvPr/>
        </p:nvCxnSpPr>
        <p:spPr>
          <a:xfrm>
            <a:off x="2647950" y="2028825"/>
            <a:ext cx="130492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E8ED5FB5-7C38-331F-57B0-9DEACA6C6D6D}"/>
              </a:ext>
            </a:extLst>
          </p:cNvPr>
          <p:cNvSpPr txBox="1"/>
          <p:nvPr/>
        </p:nvSpPr>
        <p:spPr>
          <a:xfrm>
            <a:off x="3103244" y="1680090"/>
            <a:ext cx="1076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25081376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3B8C692-9663-2CE6-73C1-70CAE0CCAEC3}"/>
              </a:ext>
            </a:extLst>
          </p:cNvPr>
          <p:cNvSpPr txBox="1"/>
          <p:nvPr/>
        </p:nvSpPr>
        <p:spPr>
          <a:xfrm>
            <a:off x="583894" y="242371"/>
            <a:ext cx="108405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S4.  EF43.fgf4 tumors treated with NAC or AAP/NAC were digested and CD45+/CD11B+/F4/80+ macrophages were analyzed for M1 markers by flow.  N=3 per condition, * ≤ 0.05. Error bars represent</a:t>
            </a:r>
            <a:r>
              <a:rPr lang="en-US" dirty="0">
                <a:solidFill>
                  <a:srgbClr val="FF0000"/>
                </a:solidFill>
              </a:rPr>
              <a:t> </a:t>
            </a:r>
            <a:r>
              <a:rPr lang="en-US" dirty="0"/>
              <a:t>± 1 SEM</a:t>
            </a:r>
          </a:p>
        </p:txBody>
      </p:sp>
    </p:spTree>
    <p:extLst>
      <p:ext uri="{BB962C8B-B14F-4D97-AF65-F5344CB8AC3E}">
        <p14:creationId xmlns:p14="http://schemas.microsoft.com/office/powerpoint/2010/main" val="3763395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0</TotalTime>
  <Words>559</Words>
  <Application>Microsoft Office PowerPoint</Application>
  <PresentationFormat>Widescreen</PresentationFormat>
  <Paragraphs>72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8" baseType="lpstr">
      <vt:lpstr>Arial</vt:lpstr>
      <vt:lpstr>Calibri</vt:lpstr>
      <vt:lpstr>Calibri Light</vt:lpstr>
      <vt:lpstr>Office Theme</vt:lpstr>
      <vt:lpstr>Supplemental Fig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upplemental methods: Primer pair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</dc:title>
  <dc:creator>Neuwelt, Alexander J.  RICVAMC</dc:creator>
  <cp:lastModifiedBy>MDPI</cp:lastModifiedBy>
  <cp:revision>5</cp:revision>
  <dcterms:created xsi:type="dcterms:W3CDTF">2023-04-28T13:20:43Z</dcterms:created>
  <dcterms:modified xsi:type="dcterms:W3CDTF">2023-09-28T01:59:24Z</dcterms:modified>
</cp:coreProperties>
</file>